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DC527-A2AA-40A2-89CE-A8AC5B3292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0685D-5A93-45EE-9FF1-256E71F4D7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14D28-2C6C-481F-9EF1-CA64CCE087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C6FF5-1771-4CB7-8994-690014B747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30C8D-CC91-45D7-B4B9-642ED1108F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A6DED-93AE-4697-A8B0-BD7B647154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B4950-1B46-4E73-9C84-E85DA9E59B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5AA38-20C1-4673-94DB-AA3AA6572A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DB97C-53A5-4F72-BB63-601A60A062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06E50-BDA2-49FB-93F0-F7862550DD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66340-E842-4DC8-A0B4-35E9C4DA93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C1603-203F-4C36-8EA5-17BC3B81EA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E50D64-FA4B-43E2-88F3-FFD67487040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90720" y="221760"/>
            <a:ext cx="7872120" cy="648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 M13 rev primer: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TTC ACA CAG GAA ACA GCT ATG ACC    3’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 T7 primer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AAT ACG ACT CAC TAT AGG GCG             3’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. M13 -20 primer: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TTG TAA AAC GAC GGC CAG TG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3’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AGT TGG TCC GCA TCC TTT CT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2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AAT CTC CCA ACC CAA ACA G   3’  ( 19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3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AAT CTA CAG CTA CCA TCC AG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4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GGT CAT ATC ATT TCC AAA CA 3’  (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5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GC CTT CGG GAC TGG GTT CA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6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AT TGA AGG CTT GCA GCC CA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7: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</a:t>
            </a:r>
            <a:r>
              <a:rPr b="1" lang="en-GB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T AGC ACT GGC ACA ACA GT 3’  ( 20 )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8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GGT TCT GAG TAC ACA GTC AG 3’   (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9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GCC AAC AGG ATG ACA TGA AA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0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AGT CCA CAG CTA TTC CTG CA 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1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GA CGA AAG GGG TCT TTT GA  3’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2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CA CCA TTA GCT GGA GAA CC  3’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3: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GT AGC CGG TAA TCC TGG CA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4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GTC ACA GAG GCT ACT ATT AC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5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CT GGA TTG GAG TCT GGC CA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6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GTG TTG GGC AAC AAA TGA TC 3’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7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CA CCC GCA CTC GAT ATC CA 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8:    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AGG CAC TGA AAG AGG AGC AG 3’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19: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CA CCC TGT ACC TGG AAA CT 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20: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CA GGG AGA AAA TGG CCA GA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21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CTA ACC ACA TAC TCC ACT GT 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22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CAA TTG AGT GCT TCA TGC CT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24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TGC CTG TTC TGC TTC GAA GT 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W26: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’  CCA CAG TAC TCA CTT TTT CC  3’  ( 20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8-19T09:27:20Z</dcterms:created>
  <dc:creator>Trefzer</dc:creator>
  <dc:description/>
  <dc:language>en-US</dc:language>
  <cp:lastModifiedBy>MDE-LAB-A1</cp:lastModifiedBy>
  <dcterms:modified xsi:type="dcterms:W3CDTF">2005-08-28T16:21:17Z</dcterms:modified>
  <cp:revision>6</cp:revision>
  <dc:subject/>
  <dc:title>Folie 1</dc:title>
</cp:coreProperties>
</file>